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2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F5AB1C69-6EDB-4FF4-983F-18BD219EF322}" styleName="Mellanmörkt format 2 - Dekorfärg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7" autoAdjust="0"/>
    <p:restoredTop sz="64688" autoAdjust="0"/>
  </p:normalViewPr>
  <p:slideViewPr>
    <p:cSldViewPr snapToGrid="0">
      <p:cViewPr varScale="1">
        <p:scale>
          <a:sx n="66" d="100"/>
          <a:sy n="66" d="100"/>
        </p:scale>
        <p:origin x="119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028442-7FA5-4E9C-BE5D-059BAC00E153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45C591-245B-487C-B5F0-74BC2E563C8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557287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1. The nucleotide sequence of the synthetic DNA. </a:t>
            </a:r>
            <a:endParaRPr lang="sv-SE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selected sequence (1377bp) are color coded to show the origin of the sequences in the RNA segments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uumal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thohantaviru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nucleotides 80-326, shown in red letters, originate from the S segment; the black letters indicate the nucleotides 37-438 and 3178-3357 of the M-segment while the blue letters indicate the nucleotides 2640-2736 and 2935-3385 of the L-segment. </a:t>
            </a:r>
            <a:endParaRPr lang="sv-SE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endParaRPr lang="en-US" sz="1200" b="1" dirty="0" smtClean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endParaRPr lang="en-US" noProof="0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5C591-245B-487C-B5F0-74BC2E563C8E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200866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här för att ändra format på underrubrik i bakgrund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24707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59856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89023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67772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4326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70312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53824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75214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4433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377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sv-SE" smtClean="0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06858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9B05C6-AA13-45C3-A8C6-0FE3CE8D1C67}" type="datetimeFigureOut">
              <a:rPr lang="sv-SE" smtClean="0"/>
              <a:t>2018-01-0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7BA50E-5D15-47DD-8002-C1DEF620E11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15029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/>
          <p:cNvSpPr/>
          <p:nvPr/>
        </p:nvSpPr>
        <p:spPr>
          <a:xfrm>
            <a:off x="1228725" y="324277"/>
            <a:ext cx="10210799" cy="49726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600" b="1" dirty="0" smtClean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Supplementary Fig. S1</a:t>
            </a:r>
            <a:endParaRPr lang="en-US" sz="1600" b="1" dirty="0" smtClean="0">
              <a:solidFill>
                <a:srgbClr val="FF0000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b="1" dirty="0" smtClean="0">
                <a:solidFill>
                  <a:srgbClr val="4F6228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 </a:t>
            </a:r>
            <a:endParaRPr lang="en-US" sz="1600" b="1" dirty="0" smtClean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1600" b="1" dirty="0" smtClean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CCATGAACAACAGCTTGTTGTTGCCAGACAAAAACTTAAGGATGCAGAGAAGGCAGTGGAAATGGACCCGGATGACGTTAACAAAAACACACTGCAAGCAAGGCAACAGACAGTGTCAGCACTGGAGGATAAACTCGCAGACTTCAAGCGACGAATGGCAGATGCTGTGTCCAGGAAGAAAATGGATACAAAGCCTACTGATCCAACTGGGATTGAGCCAGATGACCACCTCAAGGAACGATCAAG</a:t>
            </a:r>
            <a:r>
              <a:rPr lang="en-US" sz="1600" b="1" dirty="0" smtClean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AATATGGGAAAACTTAGTCCAGTTTGTCTGTATCTGTTTCTGCAGTGTCTATTACTATGGAGTAGAGGAAGTGCCAGAAACCTAAATGAACTTAAAATGGAATGTCCACACACTATTGGTTTGGGTCAAGGCCTTGTCATTGGTTCAGTGGAGTTACCACCTGTTCCAGTACAACAAGTAGAGTCTTTGAAGTTGGAGAGTTCCTGTAATTTTGATTTACACACTAGCACAGCAACCCAGCAATCATTTACAAAATGGACATGGGAAATGAAGGATGATTTAGCTGAAAACACTCAAGCATCGTCAACAAGTTTTCAAACAAAAAGTAGTGAAGTGAATTTAAGAGGGTTGTGTTTAATTCCCCCCTTAGTGGTTGAAACAGCATCACGGACCCGGAAGACTCATTCTGGTTCAAAATTTATGTGTTGTCATGATACAAAGTGCTCTAGTACAGGCCTGGTTGCAGCTGCACCACATTTAGACCGGGTAACAGGGTTTAATCAAGCCGACAGTGACAAGATTTTTGATGATGGTGCACCAGAATGTGGCATGTCTTGTTGGTTTAAAAAATCAGGTGAATG</a:t>
            </a:r>
            <a:r>
              <a:rPr lang="en-US" sz="1600" b="1" dirty="0" smtClean="0">
                <a:solidFill>
                  <a:srgbClr val="00B0F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TATGAGCAGACAAAAAAACAAAGGGCACAAGCAAGAATTGTTAGGAAATATCAAAGAACTGAGGCTGATAGAGGTTTTTTTATTACTACCTTACCT</a:t>
            </a:r>
            <a:r>
              <a:rPr lang="en-US" sz="1600" b="1" dirty="0" smtClean="0">
                <a:solidFill>
                  <a:srgbClr val="00B0F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TGTATGTTAGTGATAATGCCACAAAATGGTCACCTGGTGATAATTCAGCTAAGTTCCGGCGAGGGACACAATCATTATATGATGGGCTGCGTGATGATAAACTAAAAAACTGTGTAGTTGATGCTTTGAGGAATATATATGAGACAGATTTCTTTATATCTAGGAAATTACATAGATATATAGACAATATGGGTGAGCTGTCTGAGGAGGTATTAGACTTCTTATCATTTTTCCCAAATAAAATATCTGCTTCAATTAAAGGAAATTGGTTACAGGGTAATTTAAATAAATGTTCGTCTTTATTTGGGGCTGCAATATCATTATTATTTAAGCGTGTATGGGGCAAACTATATCCAGAATTGGAGTGTTTCTTTGAGTTTGCTCATCATTCTGATGATGCTTTATTTATTTATGGTTATTTAGAGCCAGTGGA</a:t>
            </a:r>
            <a:r>
              <a:rPr lang="en-US" sz="1600" b="1" dirty="0" smtClean="0">
                <a:solidFill>
                  <a:srgbClr val="00B0F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GATGGTAGAGAGTGGA</a:t>
            </a:r>
            <a:endParaRPr lang="en-US" sz="1600" b="1" dirty="0">
              <a:solidFill>
                <a:srgbClr val="00B0F0"/>
              </a:solidFill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3848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9</TotalTime>
  <Words>82</Words>
  <Application>Microsoft Office PowerPoint</Application>
  <PresentationFormat>Bredbild</PresentationFormat>
  <Paragraphs>6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-tema</vt:lpstr>
      <vt:lpstr>PowerPoint-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Julia Wigren Byström</dc:creator>
  <cp:lastModifiedBy>Göran Bucht</cp:lastModifiedBy>
  <cp:revision>70</cp:revision>
  <dcterms:created xsi:type="dcterms:W3CDTF">2017-04-20T08:29:07Z</dcterms:created>
  <dcterms:modified xsi:type="dcterms:W3CDTF">2018-01-06T11:30:22Z</dcterms:modified>
</cp:coreProperties>
</file>